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3" autoAdjust="0"/>
    <p:restoredTop sz="94660"/>
  </p:normalViewPr>
  <p:slideViewPr>
    <p:cSldViewPr snapToGrid="0" showGuides="1">
      <p:cViewPr varScale="1">
        <p:scale>
          <a:sx n="103" d="100"/>
          <a:sy n="103" d="100"/>
        </p:scale>
        <p:origin x="798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EBD3E1-6326-EAEA-AA4E-CB5664E984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02D0526-7E61-4955-C031-9EA89C7562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DF2C1E-38EC-8B8A-A7BE-EC040CC8A6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AADFBC-C91F-5CBC-54B3-4C658984D5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52583A-2352-4C78-86BB-774E98FFE2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58537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EE30B9-C040-132F-A1C4-8172C28003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A03955B-6253-0D82-33E2-EDD1B7AB28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9A5B06-6F2A-5AE5-BE9C-DD07ECCCD6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FEE445-1621-FBC9-E792-43D7609863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2369B8-D6CE-27EA-7498-70B34AE5C0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816574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F880743-1CFB-AC71-338B-581B6772AD7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010A6E-5332-4B08-0A1D-0DC9340D06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1D51BD-84B4-7976-24EC-094010A8F0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331B07-82A2-E942-D06E-FFC5B0D4C3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AF6A76-8A1F-0688-EE6F-2078EAFE5A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755514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F3E397-79D5-30F9-A8C0-F3B86E15F7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9610C1-7A98-BF48-A2AF-683559E1A8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00C6C2-AA6B-EB49-2583-64B6A950F8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DCBB0F-A3C7-9429-880E-1FC64B1959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791E40-FF26-D932-0EF5-9DDB647766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2422116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73D8DF-71DA-8218-28D6-E7EC6AE785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1B982E-D9EE-5835-E4D2-350C5DAE5F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E7E71C-5258-791B-3B64-E2B907D766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4F21D1-DCBC-169D-670B-397A75146F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FD0D0E-E25F-538C-3CED-F7DB0DF359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740480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D48F06-69FF-335F-695D-069C1F7E31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8A1050-E907-ECD8-155C-B94F5451174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03AD79C-6A2F-E8B2-F807-B0ADDE505B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77B32F-B922-FC4C-493F-BEAC651157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9B2302-3A20-03B8-4459-5A6B28CCCE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B91015-9DED-EFBE-5779-FCAC1CB788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6364862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3F1416-A4CA-1D91-A003-DD2AAF4356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432463-0B34-A737-65BB-F6FCAC0A33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113B73-E643-3092-50C9-836C9273E4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A147ECC-A451-466E-6ECB-1BE0B4500B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7076EE5-C818-67D0-7AAB-5F69949C86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D4E11F5-A3FB-42D9-A9D0-EFE9095218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70E7305-6858-DBEE-881F-76F2350B17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0975E74-89A1-F5D2-9C87-2D7AC19DD2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721310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4F422E-8E1D-99B9-8B97-615EF683F8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240BCA1-6E04-5962-505B-0E17E5405D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616ACF3-E789-0CEA-3936-FD252725EC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7920E13-E437-C9B0-D852-7871D09420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36095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A46A43E-DC2B-F021-58DF-61A3C4743A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57B6230-23B2-2C7D-EF85-43A070D264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B6D0EF5-46BD-D13C-40C4-DAFB822B68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4708934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CEBB53-9C26-4294-175C-1D460F48F7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03EC4A-5007-1117-DB6C-A6FDF0C1980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1B1829-202B-854C-33F2-199B1F8804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CDE4F7-D23B-5599-8F0A-7F2F10EF1A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2A92CD-7C91-D174-09C5-DCC96EDDC5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A75C27-6ECB-2D3D-5FF3-899FB7237C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1240718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8417BF-3F53-8031-0BAB-23C8DE041D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9C1DF2B-D017-650A-D31A-5C0EA899399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2728D31-D4E1-C75A-3FC7-5C3FD85F98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22918E-FA99-6637-6D5E-D507AFDC5B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834CCB-EB1E-B7C4-EC23-60CCAECD90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CC1839-D199-4C5B-37FF-3EA45899E8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255112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A7C2DD5-AC70-7812-5B43-692C6DB307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DDEA4D-A887-84F0-E009-C3EDB043B3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696AF1-DFBC-6713-64CB-66907C7F6D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A10548-7A20-B0AA-D96C-22CF5C01CCC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8D20B0-C719-0828-4564-ACEF025D2E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2285805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04CC5E7-3607-44F2-9FB8-032AE43358F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373" t="2349" r="47791" b="50571"/>
          <a:stretch/>
        </p:blipFill>
        <p:spPr bwMode="auto">
          <a:xfrm>
            <a:off x="3890839" y="2756454"/>
            <a:ext cx="3997002" cy="2928730"/>
          </a:xfrm>
          <a:prstGeom prst="rect">
            <a:avLst/>
          </a:prstGeom>
          <a:ln>
            <a:noFill/>
          </a:ln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2294B61A-C7F0-4B39-9797-A8B5F06A6934}"/>
              </a:ext>
            </a:extLst>
          </p:cNvPr>
          <p:cNvSpPr/>
          <p:nvPr/>
        </p:nvSpPr>
        <p:spPr>
          <a:xfrm>
            <a:off x="4465639" y="3970834"/>
            <a:ext cx="2820003" cy="28388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E4E1898-7467-43CD-90B3-AE9DC5CD9E7F}"/>
              </a:ext>
            </a:extLst>
          </p:cNvPr>
          <p:cNvSpPr txBox="1"/>
          <p:nvPr/>
        </p:nvSpPr>
        <p:spPr>
          <a:xfrm>
            <a:off x="7887841" y="3958888"/>
            <a:ext cx="8034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PK3</a:t>
            </a:r>
            <a:endParaRPr lang="en-DE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55D07B1-CB6B-C7EE-252C-850022CF0963}"/>
              </a:ext>
            </a:extLst>
          </p:cNvPr>
          <p:cNvSpPr txBox="1"/>
          <p:nvPr/>
        </p:nvSpPr>
        <p:spPr>
          <a:xfrm>
            <a:off x="998926" y="1031013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t 2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10EB87C-A7CF-CBA4-64C8-C79836178F91}"/>
              </a:ext>
            </a:extLst>
          </p:cNvPr>
          <p:cNvSpPr txBox="1"/>
          <p:nvPr/>
        </p:nvSpPr>
        <p:spPr>
          <a:xfrm rot="16200000">
            <a:off x="4556937" y="2603395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B00ECC6-66FF-73D1-2D2C-EB836FDC84CF}"/>
              </a:ext>
            </a:extLst>
          </p:cNvPr>
          <p:cNvSpPr txBox="1"/>
          <p:nvPr/>
        </p:nvSpPr>
        <p:spPr>
          <a:xfrm rot="16200000">
            <a:off x="5194594" y="1393657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moderate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EA55A64-6C34-1450-9D2E-EAACC29187A0}"/>
              </a:ext>
            </a:extLst>
          </p:cNvPr>
          <p:cNvSpPr txBox="1"/>
          <p:nvPr/>
        </p:nvSpPr>
        <p:spPr>
          <a:xfrm rot="16200000">
            <a:off x="4735054" y="2314774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18C331A-37C0-B9FD-6573-36F1AE5D9B15}"/>
              </a:ext>
            </a:extLst>
          </p:cNvPr>
          <p:cNvSpPr txBox="1"/>
          <p:nvPr/>
        </p:nvSpPr>
        <p:spPr>
          <a:xfrm rot="16200000">
            <a:off x="5494343" y="2194400"/>
            <a:ext cx="13003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L-NG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764BEAF-306B-0BC8-3C3C-3852925B73FA}"/>
              </a:ext>
            </a:extLst>
          </p:cNvPr>
          <p:cNvSpPr txBox="1"/>
          <p:nvPr/>
        </p:nvSpPr>
        <p:spPr>
          <a:xfrm rot="16200000">
            <a:off x="5212732" y="2367524"/>
            <a:ext cx="95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E522F22-4B92-2C86-A673-46C944FDD2E5}"/>
              </a:ext>
            </a:extLst>
          </p:cNvPr>
          <p:cNvSpPr txBox="1"/>
          <p:nvPr/>
        </p:nvSpPr>
        <p:spPr>
          <a:xfrm rot="16200000">
            <a:off x="5655440" y="1439914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high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2826972E-2541-1519-851C-8C8B9C6EEC54}"/>
              </a:ext>
            </a:extLst>
          </p:cNvPr>
          <p:cNvCxnSpPr>
            <a:cxnSpLocks/>
          </p:cNvCxnSpPr>
          <p:nvPr/>
        </p:nvCxnSpPr>
        <p:spPr>
          <a:xfrm>
            <a:off x="4577630" y="2947408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C22A1150-E084-9222-3CF0-B97F24B9042F}"/>
              </a:ext>
            </a:extLst>
          </p:cNvPr>
          <p:cNvCxnSpPr>
            <a:cxnSpLocks/>
          </p:cNvCxnSpPr>
          <p:nvPr/>
        </p:nvCxnSpPr>
        <p:spPr>
          <a:xfrm>
            <a:off x="5041456" y="2947408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7060ED05-7804-D323-0B97-FFE3860766C0}"/>
              </a:ext>
            </a:extLst>
          </p:cNvPr>
          <p:cNvCxnSpPr>
            <a:cxnSpLocks/>
          </p:cNvCxnSpPr>
          <p:nvPr/>
        </p:nvCxnSpPr>
        <p:spPr>
          <a:xfrm>
            <a:off x="5502301" y="2947159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CA4532CB-3E28-3CAE-7363-BA48374508E6}"/>
              </a:ext>
            </a:extLst>
          </p:cNvPr>
          <p:cNvCxnSpPr>
            <a:cxnSpLocks/>
          </p:cNvCxnSpPr>
          <p:nvPr/>
        </p:nvCxnSpPr>
        <p:spPr>
          <a:xfrm>
            <a:off x="5956781" y="2947159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773AF179-F870-F970-1C4A-43CF723E1D97}"/>
              </a:ext>
            </a:extLst>
          </p:cNvPr>
          <p:cNvCxnSpPr>
            <a:cxnSpLocks/>
          </p:cNvCxnSpPr>
          <p:nvPr/>
        </p:nvCxnSpPr>
        <p:spPr>
          <a:xfrm>
            <a:off x="6406430" y="2949574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43F6DD0D-6300-7D90-2D7A-F38DB4220F0F}"/>
              </a:ext>
            </a:extLst>
          </p:cNvPr>
          <p:cNvCxnSpPr>
            <a:cxnSpLocks/>
          </p:cNvCxnSpPr>
          <p:nvPr/>
        </p:nvCxnSpPr>
        <p:spPr>
          <a:xfrm>
            <a:off x="6863630" y="2947159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AD319044-EDEC-E6B2-2EF8-F9CFC163CDE3}"/>
              </a:ext>
            </a:extLst>
          </p:cNvPr>
          <p:cNvSpPr txBox="1"/>
          <p:nvPr/>
        </p:nvSpPr>
        <p:spPr>
          <a:xfrm>
            <a:off x="3987390" y="2983077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722EEB6-ADCC-080D-6022-E98B034C19E7}"/>
              </a:ext>
            </a:extLst>
          </p:cNvPr>
          <p:cNvSpPr txBox="1"/>
          <p:nvPr/>
        </p:nvSpPr>
        <p:spPr>
          <a:xfrm>
            <a:off x="3606585" y="3262544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mricasan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5582454-5885-813E-4A6E-0D4DC1C760EA}"/>
              </a:ext>
            </a:extLst>
          </p:cNvPr>
          <p:cNvSpPr txBox="1"/>
          <p:nvPr/>
        </p:nvSpPr>
        <p:spPr>
          <a:xfrm>
            <a:off x="4513025" y="2966351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+    +    +    +    +    +   +   +    +   +    +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B85F4A1-8820-3E7C-524F-FD8C61A13D99}"/>
              </a:ext>
            </a:extLst>
          </p:cNvPr>
          <p:cNvSpPr txBox="1"/>
          <p:nvPr/>
        </p:nvSpPr>
        <p:spPr>
          <a:xfrm>
            <a:off x="4513025" y="3215737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-    +    -    +    -    +   -   +    -   +    -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E8713F14-7274-4BEC-8336-DBDC5437E798}"/>
              </a:ext>
            </a:extLst>
          </p:cNvPr>
          <p:cNvCxnSpPr>
            <a:cxnSpLocks/>
          </p:cNvCxnSpPr>
          <p:nvPr/>
        </p:nvCxnSpPr>
        <p:spPr>
          <a:xfrm>
            <a:off x="4102738" y="4508389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36">
            <a:extLst>
              <a:ext uri="{FF2B5EF4-FFF2-40B4-BE49-F238E27FC236}">
                <a16:creationId xmlns:a16="http://schemas.microsoft.com/office/drawing/2014/main" id="{FD4E685A-AD48-440B-8D9A-F3E10CFAE17B}"/>
              </a:ext>
            </a:extLst>
          </p:cNvPr>
          <p:cNvSpPr txBox="1"/>
          <p:nvPr/>
        </p:nvSpPr>
        <p:spPr>
          <a:xfrm>
            <a:off x="3774352" y="436631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8D863EF0-38AA-403F-87A3-AEEF3A4D26E2}"/>
              </a:ext>
            </a:extLst>
          </p:cNvPr>
          <p:cNvCxnSpPr>
            <a:cxnSpLocks/>
          </p:cNvCxnSpPr>
          <p:nvPr/>
        </p:nvCxnSpPr>
        <p:spPr>
          <a:xfrm>
            <a:off x="4104552" y="4787193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Box 38">
            <a:extLst>
              <a:ext uri="{FF2B5EF4-FFF2-40B4-BE49-F238E27FC236}">
                <a16:creationId xmlns:a16="http://schemas.microsoft.com/office/drawing/2014/main" id="{478B7EB3-192F-40EE-AC6A-9FCD85C94BD7}"/>
              </a:ext>
            </a:extLst>
          </p:cNvPr>
          <p:cNvSpPr txBox="1"/>
          <p:nvPr/>
        </p:nvSpPr>
        <p:spPr>
          <a:xfrm>
            <a:off x="3776166" y="464512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F62C0BA1-F56C-44CF-B693-327D60ABEBE0}"/>
              </a:ext>
            </a:extLst>
          </p:cNvPr>
          <p:cNvCxnSpPr>
            <a:cxnSpLocks/>
          </p:cNvCxnSpPr>
          <p:nvPr/>
        </p:nvCxnSpPr>
        <p:spPr>
          <a:xfrm>
            <a:off x="4104021" y="4112333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40">
            <a:extLst>
              <a:ext uri="{FF2B5EF4-FFF2-40B4-BE49-F238E27FC236}">
                <a16:creationId xmlns:a16="http://schemas.microsoft.com/office/drawing/2014/main" id="{AAACB78F-C924-4654-ABB7-B269569E0629}"/>
              </a:ext>
            </a:extLst>
          </p:cNvPr>
          <p:cNvSpPr txBox="1"/>
          <p:nvPr/>
        </p:nvSpPr>
        <p:spPr>
          <a:xfrm>
            <a:off x="3775635" y="397026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593D6652-B5D3-4171-A521-783B6A33E412}"/>
              </a:ext>
            </a:extLst>
          </p:cNvPr>
          <p:cNvCxnSpPr>
            <a:cxnSpLocks/>
          </p:cNvCxnSpPr>
          <p:nvPr/>
        </p:nvCxnSpPr>
        <p:spPr>
          <a:xfrm>
            <a:off x="4102547" y="3885858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Box 42">
            <a:extLst>
              <a:ext uri="{FF2B5EF4-FFF2-40B4-BE49-F238E27FC236}">
                <a16:creationId xmlns:a16="http://schemas.microsoft.com/office/drawing/2014/main" id="{58AEF2BF-0A7A-40E0-9B4F-C2A4758FFF89}"/>
              </a:ext>
            </a:extLst>
          </p:cNvPr>
          <p:cNvSpPr txBox="1"/>
          <p:nvPr/>
        </p:nvSpPr>
        <p:spPr>
          <a:xfrm>
            <a:off x="3774161" y="373701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3262E812-208B-4F8D-8F90-289F61980592}"/>
              </a:ext>
            </a:extLst>
          </p:cNvPr>
          <p:cNvCxnSpPr>
            <a:cxnSpLocks/>
          </p:cNvCxnSpPr>
          <p:nvPr/>
        </p:nvCxnSpPr>
        <p:spPr>
          <a:xfrm>
            <a:off x="4102738" y="5398829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" name="TextBox 38">
            <a:extLst>
              <a:ext uri="{FF2B5EF4-FFF2-40B4-BE49-F238E27FC236}">
                <a16:creationId xmlns:a16="http://schemas.microsoft.com/office/drawing/2014/main" id="{DA2EEA57-6BD1-4AF1-B6CF-96407B025E72}"/>
              </a:ext>
            </a:extLst>
          </p:cNvPr>
          <p:cNvSpPr txBox="1"/>
          <p:nvPr/>
        </p:nvSpPr>
        <p:spPr>
          <a:xfrm>
            <a:off x="3774352" y="525675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0A772D53-1A0A-4762-8291-F7E5BBAE99D6}"/>
              </a:ext>
            </a:extLst>
          </p:cNvPr>
          <p:cNvCxnSpPr>
            <a:cxnSpLocks/>
          </p:cNvCxnSpPr>
          <p:nvPr/>
        </p:nvCxnSpPr>
        <p:spPr>
          <a:xfrm>
            <a:off x="4102547" y="3755474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TextBox 42">
            <a:extLst>
              <a:ext uri="{FF2B5EF4-FFF2-40B4-BE49-F238E27FC236}">
                <a16:creationId xmlns:a16="http://schemas.microsoft.com/office/drawing/2014/main" id="{569A272D-25F7-4076-84A1-1B023C102567}"/>
              </a:ext>
            </a:extLst>
          </p:cNvPr>
          <p:cNvSpPr txBox="1"/>
          <p:nvPr/>
        </p:nvSpPr>
        <p:spPr>
          <a:xfrm>
            <a:off x="3689201" y="358631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892583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3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smin Carvalho Schäfer</dc:creator>
  <cp:lastModifiedBy>mnagata</cp:lastModifiedBy>
  <cp:revision>5</cp:revision>
  <dcterms:created xsi:type="dcterms:W3CDTF">2024-08-13T14:46:47Z</dcterms:created>
  <dcterms:modified xsi:type="dcterms:W3CDTF">2024-08-14T22:20:38Z</dcterms:modified>
</cp:coreProperties>
</file>